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5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0" d="100"/>
          <a:sy n="80" d="100"/>
        </p:scale>
        <p:origin x="-2646" y="-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5C75CBB-1157-40F9-AFF8-8E83DF54C446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458D1B7-231B-4C77-9CA4-7C508C34A98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843467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CA" dirty="0" smtClean="0"/>
              <a:t>Supplementary</a:t>
            </a:r>
            <a:r>
              <a:rPr lang="en-CA" baseline="0" dirty="0" smtClean="0"/>
              <a:t> </a:t>
            </a:r>
            <a:r>
              <a:rPr lang="en-CA" baseline="0" smtClean="0"/>
              <a:t>Figure </a:t>
            </a:r>
            <a:r>
              <a:rPr lang="en-CA" baseline="0" smtClean="0"/>
              <a:t>3</a:t>
            </a:r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2CC88B7-DE8F-450E-A02D-FEED2AE35043}" type="slidenum">
              <a:rPr lang="en-CA" smtClean="0"/>
              <a:t>1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277257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347105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842123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063311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343563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154426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973256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254742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593412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167035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008684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341175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711610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9" name="Picture 5" descr="T:\Transfer\Cindy\Old-Folders\For-Jane\PROTECT2\Validation\SIMMS\No-Chemo\Survival\2015-07-29_TEAM-IOT_KM-TEAM-Validation_DRFS_SIMMS-Only_No-Chemo_Quartiles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76118" y="1100364"/>
            <a:ext cx="3181333" cy="278366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1112107" y="849070"/>
            <a:ext cx="45421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600" dirty="0" smtClean="0">
                <a:latin typeface="Arial Narrow" panose="020B0606020202030204" pitchFamily="34" charset="0"/>
              </a:rPr>
              <a:t>Validation: 95-Gene Risk Model with no Clinical Covariates</a:t>
            </a:r>
            <a:endParaRPr lang="en-CA" sz="1600" dirty="0">
              <a:latin typeface="Arial Narrow" panose="020B060602020203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52305" y="1121003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000" b="1" dirty="0"/>
              <a:t>A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277984" y="1147554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000" b="1" dirty="0" smtClean="0"/>
              <a:t>B</a:t>
            </a:r>
            <a:endParaRPr lang="en-CA" sz="20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44624" y="4442221"/>
            <a:ext cx="3209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000" b="1" dirty="0" smtClean="0"/>
              <a:t>C</a:t>
            </a:r>
            <a:endParaRPr lang="en-CA" sz="20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3346605" y="4459922"/>
            <a:ext cx="34657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000" b="1" dirty="0" smtClean="0"/>
              <a:t>D</a:t>
            </a:r>
            <a:endParaRPr lang="en-CA" sz="20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1189674" y="4161438"/>
            <a:ext cx="41093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600" dirty="0" smtClean="0">
                <a:latin typeface="Arial Narrow" panose="020B0606020202030204" pitchFamily="34" charset="0"/>
              </a:rPr>
              <a:t>Validation: 95-Gene Risk Model + Clinical Covariates</a:t>
            </a:r>
            <a:endParaRPr lang="en-CA" sz="1600" dirty="0">
              <a:latin typeface="Arial Narrow" panose="020B0606020202030204" pitchFamily="34" charset="0"/>
            </a:endParaRPr>
          </a:p>
        </p:txBody>
      </p:sp>
      <p:pic>
        <p:nvPicPr>
          <p:cNvPr id="6148" name="Picture 4" descr="T:\Transfer\Cindy\Old-Folders\For-Jane\PROTECT2\Validation\SIMMS\No-Chemo\Survival\2015-07-29_TEAM-IOT_KM-TEAM-Validation_DRFS_SIMMS-Only_No-Chemo.pn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1225" y="1190768"/>
            <a:ext cx="2480327" cy="248032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51" name="Picture 7" descr="T:\Transfer\Cindy\Old-Folders\For-Jane\PROTECT2\Validation\SIMMS\No-Chemo\Survival\2015-07-29_TEAM-IOT_KM-TEAM-Validation_DRFS_SIMMS-Clinical_No-Chemo_Quartiles.pn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53691" y="4438708"/>
            <a:ext cx="2949158" cy="25805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0" name="Picture 2" descr="T:\Transfer\Cindy\TEAM\Integration-of-Tests\Output\Validation\PROTECT2\No-Chemo_No-Chemo\Survival\Median\2015-08-17_TEAM-IOT_KM-TEAM-Validation_DRFS_SIMMS-Clinical_No-Chemo.pn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3327" y="4439859"/>
            <a:ext cx="2579362" cy="257936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2267150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5</Words>
  <Application>Microsoft Office PowerPoint</Application>
  <PresentationFormat>On-screen Show (4:3)</PresentationFormat>
  <Paragraphs>8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ne Bayani</dc:creator>
  <cp:lastModifiedBy>Jane Bayani</cp:lastModifiedBy>
  <cp:revision>10</cp:revision>
  <dcterms:created xsi:type="dcterms:W3CDTF">2016-05-05T14:49:32Z</dcterms:created>
  <dcterms:modified xsi:type="dcterms:W3CDTF">2016-07-29T18:37:00Z</dcterms:modified>
</cp:coreProperties>
</file>